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1618"/>
    <p:restoredTop sz="94627"/>
  </p:normalViewPr>
  <p:slideViewPr>
    <p:cSldViewPr snapToGrid="0">
      <p:cViewPr varScale="1">
        <p:scale>
          <a:sx n="105" d="100"/>
          <a:sy n="105" d="100"/>
        </p:scale>
        <p:origin x="147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44A061-747C-374F-88AC-9FA763811EE3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0F669A-29B0-E544-9255-0524CFC8E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7300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0F669A-29B0-E544-9255-0524CFC8E4E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112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BFA6-C121-7949-95B5-7E3CEB658D72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4450D-325C-9C4A-93F9-B4B3AA9316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3078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BFA6-C121-7949-95B5-7E3CEB658D72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4450D-325C-9C4A-93F9-B4B3AA9316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1260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BFA6-C121-7949-95B5-7E3CEB658D72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4450D-325C-9C4A-93F9-B4B3AA9316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3550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BFA6-C121-7949-95B5-7E3CEB658D72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4450D-325C-9C4A-93F9-B4B3AA9316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996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BFA6-C121-7949-95B5-7E3CEB658D72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4450D-325C-9C4A-93F9-B4B3AA9316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8454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BFA6-C121-7949-95B5-7E3CEB658D72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4450D-325C-9C4A-93F9-B4B3AA9316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4981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BFA6-C121-7949-95B5-7E3CEB658D72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4450D-325C-9C4A-93F9-B4B3AA9316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157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BFA6-C121-7949-95B5-7E3CEB658D72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4450D-325C-9C4A-93F9-B4B3AA9316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215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BFA6-C121-7949-95B5-7E3CEB658D72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4450D-325C-9C4A-93F9-B4B3AA9316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975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BFA6-C121-7949-95B5-7E3CEB658D72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4450D-325C-9C4A-93F9-B4B3AA9316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4129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BFA6-C121-7949-95B5-7E3CEB658D72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4450D-325C-9C4A-93F9-B4B3AA9316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451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38FBFA6-C121-7949-95B5-7E3CEB658D72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864450D-325C-9C4A-93F9-B4B3AA9316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588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table with numbers and symbols&#10;&#10;Description automatically generated">
            <a:extLst>
              <a:ext uri="{FF2B5EF4-FFF2-40B4-BE49-F238E27FC236}">
                <a16:creationId xmlns:a16="http://schemas.microsoft.com/office/drawing/2014/main" id="{EE9CE4F4-8428-AF9A-8196-7DAD2B80CF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05104" y="3589484"/>
            <a:ext cx="5433237" cy="2002618"/>
          </a:xfrm>
          <a:prstGeom prst="rect">
            <a:avLst/>
          </a:prstGeom>
        </p:spPr>
      </p:pic>
      <p:pic>
        <p:nvPicPr>
          <p:cNvPr id="7" name="Picture 6" descr="A table with numbers and symbols&#10;&#10;Description automatically generated">
            <a:extLst>
              <a:ext uri="{FF2B5EF4-FFF2-40B4-BE49-F238E27FC236}">
                <a16:creationId xmlns:a16="http://schemas.microsoft.com/office/drawing/2014/main" id="{CC8F91A8-FFF8-B7E6-5BD7-9407254967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07688" y="1101655"/>
            <a:ext cx="5529574" cy="191154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27AB8FA-F7F8-ADD9-3093-EFD15A10145C}"/>
              </a:ext>
            </a:extLst>
          </p:cNvPr>
          <p:cNvSpPr txBox="1"/>
          <p:nvPr/>
        </p:nvSpPr>
        <p:spPr>
          <a:xfrm>
            <a:off x="5716396" y="3589484"/>
            <a:ext cx="1050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1.3B’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27C9C6B-D272-DDB4-F28D-8997EC834D42}"/>
              </a:ext>
            </a:extLst>
          </p:cNvPr>
          <p:cNvSpPr txBox="1"/>
          <p:nvPr/>
        </p:nvSpPr>
        <p:spPr>
          <a:xfrm>
            <a:off x="5748671" y="919643"/>
            <a:ext cx="9197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1.3A’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372BD77-1A5F-7242-7663-C802D095A9D9}"/>
              </a:ext>
            </a:extLst>
          </p:cNvPr>
          <p:cNvSpPr txBox="1"/>
          <p:nvPr/>
        </p:nvSpPr>
        <p:spPr>
          <a:xfrm>
            <a:off x="465836" y="5955048"/>
            <a:ext cx="1147142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upplemental Figure 1. Sensitivity Analysis. 1.3A. </a:t>
            </a:r>
            <a:r>
              <a:rPr lang="en-US" sz="2000" dirty="0"/>
              <a:t>Esophagitis ( as per Figure 3A), 1.</a:t>
            </a:r>
            <a:r>
              <a:rPr lang="en-US" sz="2000" b="1" dirty="0"/>
              <a:t>3B. </a:t>
            </a:r>
            <a:r>
              <a:rPr lang="en-US" sz="2000" dirty="0"/>
              <a:t>GERD</a:t>
            </a:r>
            <a:r>
              <a:rPr lang="en-US" sz="2000" b="1" dirty="0"/>
              <a:t> </a:t>
            </a:r>
            <a:r>
              <a:rPr lang="en-US" sz="2000" dirty="0"/>
              <a:t>( as per Figure 3B). 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75430EB8-5A82-3ADD-E699-CDB623E5722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6602" y="3687830"/>
            <a:ext cx="4605084" cy="192949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6342BA7-CEAA-F342-F70C-9153214E936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46602" y="1181253"/>
            <a:ext cx="4605084" cy="1831949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E781EE40-0C1C-9E48-BD62-C6AF057C9CAE}"/>
              </a:ext>
            </a:extLst>
          </p:cNvPr>
          <p:cNvSpPr txBox="1"/>
          <p:nvPr/>
        </p:nvSpPr>
        <p:spPr>
          <a:xfrm>
            <a:off x="7763641" y="366560"/>
            <a:ext cx="2910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Sensitivity Analysi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73FC714-98D1-2273-09B0-79AB7BB24CBF}"/>
              </a:ext>
            </a:extLst>
          </p:cNvPr>
          <p:cNvSpPr txBox="1"/>
          <p:nvPr/>
        </p:nvSpPr>
        <p:spPr>
          <a:xfrm>
            <a:off x="1416989" y="366560"/>
            <a:ext cx="2910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Meta-Analysi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6E703C3-B975-A8FE-64F4-598ED7D2A10D}"/>
              </a:ext>
            </a:extLst>
          </p:cNvPr>
          <p:cNvSpPr txBox="1"/>
          <p:nvPr/>
        </p:nvSpPr>
        <p:spPr>
          <a:xfrm>
            <a:off x="292850" y="3589484"/>
            <a:ext cx="9197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1.3B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BEB1E4A-93BD-7EB4-B48A-A415911D6E2E}"/>
              </a:ext>
            </a:extLst>
          </p:cNvPr>
          <p:cNvSpPr txBox="1"/>
          <p:nvPr/>
        </p:nvSpPr>
        <p:spPr>
          <a:xfrm>
            <a:off x="274369" y="918740"/>
            <a:ext cx="9197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1.3A.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487DD81-3F98-3847-C899-4C3A0519B951}"/>
              </a:ext>
            </a:extLst>
          </p:cNvPr>
          <p:cNvSpPr/>
          <p:nvPr/>
        </p:nvSpPr>
        <p:spPr>
          <a:xfrm>
            <a:off x="1025322" y="1596366"/>
            <a:ext cx="2655417" cy="13898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06397A2-61D8-6B42-0B95-CB963D8804F2}"/>
              </a:ext>
            </a:extLst>
          </p:cNvPr>
          <p:cNvSpPr/>
          <p:nvPr/>
        </p:nvSpPr>
        <p:spPr>
          <a:xfrm>
            <a:off x="1077991" y="4404719"/>
            <a:ext cx="2655417" cy="13898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755F7E6C-E612-D879-1FC7-F2809BC538EF}"/>
              </a:ext>
            </a:extLst>
          </p:cNvPr>
          <p:cNvSpPr/>
          <p:nvPr/>
        </p:nvSpPr>
        <p:spPr>
          <a:xfrm>
            <a:off x="8727796" y="5149650"/>
            <a:ext cx="444679" cy="14066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66AA563A-93E4-4A9E-42FE-0275080950AA}"/>
              </a:ext>
            </a:extLst>
          </p:cNvPr>
          <p:cNvSpPr/>
          <p:nvPr/>
        </p:nvSpPr>
        <p:spPr>
          <a:xfrm>
            <a:off x="8858250" y="2574989"/>
            <a:ext cx="444679" cy="14066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1817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2</TotalTime>
  <Words>37</Words>
  <Application>Microsoft Office PowerPoint</Application>
  <PresentationFormat>Widescreen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da fl</dc:creator>
  <cp:lastModifiedBy>Mahmoodi, Tara</cp:lastModifiedBy>
  <cp:revision>16</cp:revision>
  <cp:lastPrinted>2025-05-06T20:29:15Z</cp:lastPrinted>
  <dcterms:created xsi:type="dcterms:W3CDTF">2025-01-28T14:55:02Z</dcterms:created>
  <dcterms:modified xsi:type="dcterms:W3CDTF">2025-05-27T17:46:12Z</dcterms:modified>
</cp:coreProperties>
</file>